
<file path=[Content_Types].xml><?xml version="1.0" encoding="utf-8"?>
<Types xmlns="http://schemas.openxmlformats.org/package/2006/content-types">
  <Default Extension="tmp" ContentType="image/png"/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3" d="100"/>
          <a:sy n="73" d="100"/>
        </p:scale>
        <p:origin x="61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95A68A-893A-BC20-A9D2-F7D04E97D2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25B9F96-179D-B2D0-2536-F798EA61F7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861BDD-769B-5939-CB43-9B6868D732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C2B97-A617-4116-9727-78A6D6F1203D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2171E6-8421-C957-02B5-5162F68E9D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DB825B-9339-02C4-6141-AB76FE03C3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68DC-26F2-4DA3-95D7-CAF9784A4C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51342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682817-52C6-6A47-01C6-1B31307720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EB22A2B-E836-2BFB-9D55-ECA3C8FA12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E75E08-AEDE-22FB-DC29-87B570C8D4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C2B97-A617-4116-9727-78A6D6F1203D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8CACC2-E1B3-F4CF-5527-E56B4C2E23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DA6A31-1E44-497C-33FE-A4062D88AA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68DC-26F2-4DA3-95D7-CAF9784A4C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247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B07C80E-9C40-76C2-A51F-BF007EECEE8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F27F9FD-CECF-8032-EF53-4F8F0EE4B2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CCC59C-66D0-CBB4-26CD-534687CF5D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C2B97-A617-4116-9727-78A6D6F1203D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DE7E94-CC36-06D0-0867-2D727227BC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684431-77F0-FCEE-9C9A-3FAB42DE34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68DC-26F2-4DA3-95D7-CAF9784A4C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63829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50030A-28D9-8324-8E03-A8AA39E396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D524F6-3C47-11A6-38BA-7857069789F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900769-C980-8372-3235-3A24B0A1C8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C2B97-A617-4116-9727-78A6D6F1203D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08308A-261D-E268-E520-AACD616C8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C46780-0EF3-4CDC-1B7F-611E928FC1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68DC-26F2-4DA3-95D7-CAF9784A4C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67406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8FBA06-BFB5-BD56-11A5-ABA941C671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65A056-D6B4-9883-6046-CE232B65C7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39CAD6-2372-30B0-ADA8-BCB739A17B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C2B97-A617-4116-9727-78A6D6F1203D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E65DAD-AC6E-10C4-3CF2-700C2258B4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60020B-3055-9E6A-244D-84E38870CC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68DC-26F2-4DA3-95D7-CAF9784A4C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08957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340628-8715-100E-A6C5-584A13C9D1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65823F-BC20-86E6-3E2F-46B025B6628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3A6017-ED37-4D79-1F02-27843A71E8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5B6009-4FF3-8B2F-8F3D-9D12CA61BF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C2B97-A617-4116-9727-78A6D6F1203D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38B1A6-2900-5420-0133-20342139B8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2D7EF7-4AD6-B8A6-8EB1-6A2EA63518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68DC-26F2-4DA3-95D7-CAF9784A4C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6511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0E2C8C-F4D1-29F4-B3A3-208474F794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B5E7579-A0BF-EDDB-AC01-77CCE68090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0F1A851-6734-0FFB-D6A7-600AA9D957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D030AF2-E74E-E0B6-EE58-341A343565E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7FC6188-4B31-418C-5FA8-72A564D6E0D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B352ED0-8AD5-9FE3-DA11-765BE9AD7D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C2B97-A617-4116-9727-78A6D6F1203D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E2EB2B2-0C8E-6314-E511-D4B2AF8EC1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777737A-B845-3892-C0C1-23EC313C3B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68DC-26F2-4DA3-95D7-CAF9784A4C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80652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9908BB-EFD5-4664-E580-1AC61670E2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E32939E-42E2-25EE-B39F-9A2797523E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C2B97-A617-4116-9727-78A6D6F1203D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F21FEAE-402A-E42B-3789-B67DD55EB6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1079175-9D1D-202D-282B-9B88849578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68DC-26F2-4DA3-95D7-CAF9784A4C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0268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768DFBD-04DD-A737-E3F2-D422BE5E28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C2B97-A617-4116-9727-78A6D6F1203D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6023FDF-3A06-D4D0-2A96-0D1F529004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4668C18-D1E2-0FB1-734A-494F2717A5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68DC-26F2-4DA3-95D7-CAF9784A4C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00044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5A35DD-64F5-6295-6878-4180A82FEC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25D961-C5E9-C123-D033-ED68F4E5BC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2E8B475-C6A6-94D1-5F13-8AEB282CD0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E8E0B1-1BB2-7575-07A2-3A701EADC3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C2B97-A617-4116-9727-78A6D6F1203D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6A9C98-7816-6ED5-0BB0-B10059BFDB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E9D249-0AED-988A-B7A7-FA7AA1521A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68DC-26F2-4DA3-95D7-CAF9784A4C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78742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C51648-4682-0E70-FDC8-B86CBCE8D6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CE22BEB-0F06-5B73-50E2-18A300A099C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984D01F-0B96-E597-BD5C-12C286FC40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FC690E1-3E0C-8B63-A9C0-52ADDF242E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C2B97-A617-4116-9727-78A6D6F1203D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C586CC-8646-6C24-A9FE-43EFAF7876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38626A-145A-8FB1-3958-1CCF302F98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68DC-26F2-4DA3-95D7-CAF9784A4C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01718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1165081-49F2-BBA1-75CE-5398F8474A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2E339F-475B-E50C-D368-11202C693B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5222AE-CDD5-0B1B-DE46-FB45A7A1A16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AC2B97-A617-4116-9727-78A6D6F1203D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284C5C-F266-19C7-CF7E-32247D46ECB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B385DB-8319-1C3E-9427-66B43A2028B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AB68DC-26F2-4DA3-95D7-CAF9784A4C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79819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mp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mp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F98BFBB-4CC1-05DD-56CF-AA3468FD167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" b="299"/>
          <a:stretch/>
        </p:blipFill>
        <p:spPr>
          <a:xfrm>
            <a:off x="1476102" y="960582"/>
            <a:ext cx="10571633" cy="566189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CA12699-EAD3-8511-2207-211BED7DD500}"/>
              </a:ext>
            </a:extLst>
          </p:cNvPr>
          <p:cNvSpPr txBox="1"/>
          <p:nvPr/>
        </p:nvSpPr>
        <p:spPr>
          <a:xfrm>
            <a:off x="1625600" y="235526"/>
            <a:ext cx="939338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 smtClean="0">
                <a:solidFill>
                  <a:srgbClr val="FF0000"/>
                </a:solidFill>
              </a:rPr>
              <a:t>S2, Slide 1: Boxplot </a:t>
            </a:r>
            <a:r>
              <a:rPr lang="en-US" sz="2800" b="1" dirty="0">
                <a:solidFill>
                  <a:srgbClr val="FF0000"/>
                </a:solidFill>
              </a:rPr>
              <a:t>of GSE29111 &amp; GSE60993 before remove batch effect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6BD3BF8-FAAA-CBE4-CB2A-A273DA4F2E1C}"/>
              </a:ext>
            </a:extLst>
          </p:cNvPr>
          <p:cNvSpPr txBox="1"/>
          <p:nvPr/>
        </p:nvSpPr>
        <p:spPr>
          <a:xfrm rot="16200000">
            <a:off x="-905517" y="3257214"/>
            <a:ext cx="3745809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B Nazanin" panose="00000400000000000000" pitchFamily="2" charset="-78"/>
              </a:rPr>
              <a:t>Gene </a:t>
            </a:r>
            <a:r>
              <a:rPr lang="en-US" sz="28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B Nazanin" panose="00000400000000000000" pitchFamily="2" charset="-78"/>
              </a:rPr>
              <a:t>Expression value</a:t>
            </a:r>
            <a:endParaRPr lang="en-US" sz="2800" b="1" dirty="0"/>
          </a:p>
        </p:txBody>
      </p:sp>
    </p:spTree>
    <p:extLst>
      <p:ext uri="{BB962C8B-B14F-4D97-AF65-F5344CB8AC3E}">
        <p14:creationId xmlns:p14="http://schemas.microsoft.com/office/powerpoint/2010/main" val="22495742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461B429B-86AA-E3E0-95D1-7D3C70C7694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7726" y="738909"/>
            <a:ext cx="10627148" cy="577734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59A3DF5-495B-D10E-2C8D-64E09051687C}"/>
              </a:ext>
            </a:extLst>
          </p:cNvPr>
          <p:cNvSpPr txBox="1"/>
          <p:nvPr/>
        </p:nvSpPr>
        <p:spPr>
          <a:xfrm>
            <a:off x="1560945" y="215689"/>
            <a:ext cx="9439564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800" b="1" dirty="0">
                <a:solidFill>
                  <a:srgbClr val="FF0000"/>
                </a:solidFill>
              </a:rPr>
              <a:t>S2, Slide </a:t>
            </a:r>
            <a:r>
              <a:rPr lang="en-US" sz="2800" b="1" dirty="0" smtClean="0">
                <a:solidFill>
                  <a:srgbClr val="FF0000"/>
                </a:solidFill>
              </a:rPr>
              <a:t>2: </a:t>
            </a:r>
            <a:r>
              <a:rPr lang="en-US" sz="2800" b="1" dirty="0">
                <a:solidFill>
                  <a:srgbClr val="FF0000"/>
                </a:solidFill>
              </a:rPr>
              <a:t>Boxplot </a:t>
            </a:r>
            <a:r>
              <a:rPr lang="en-US" sz="2800" b="1" dirty="0">
                <a:solidFill>
                  <a:srgbClr val="FF0000"/>
                </a:solidFill>
              </a:rPr>
              <a:t>of GSE29111 &amp; GSE60993 after remove batch effect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6BD3BF8-FAAA-CBE4-CB2A-A273DA4F2E1C}"/>
              </a:ext>
            </a:extLst>
          </p:cNvPr>
          <p:cNvSpPr txBox="1"/>
          <p:nvPr/>
        </p:nvSpPr>
        <p:spPr>
          <a:xfrm rot="16200000">
            <a:off x="-2095850" y="3089013"/>
            <a:ext cx="5812975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8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B Nazanin" panose="00000400000000000000" pitchFamily="2" charset="-78"/>
              </a:rPr>
              <a:t>Normalized Gene Expression value</a:t>
            </a:r>
            <a:endParaRPr lang="en-US" sz="2800" b="1" dirty="0"/>
          </a:p>
        </p:txBody>
      </p:sp>
    </p:spTree>
    <p:extLst>
      <p:ext uri="{BB962C8B-B14F-4D97-AF65-F5344CB8AC3E}">
        <p14:creationId xmlns:p14="http://schemas.microsoft.com/office/powerpoint/2010/main" val="31392606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59A3DF5-495B-D10E-2C8D-64E09051687C}"/>
              </a:ext>
            </a:extLst>
          </p:cNvPr>
          <p:cNvSpPr txBox="1"/>
          <p:nvPr/>
        </p:nvSpPr>
        <p:spPr>
          <a:xfrm>
            <a:off x="1560945" y="189563"/>
            <a:ext cx="9439564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800" b="1" dirty="0">
                <a:solidFill>
                  <a:srgbClr val="FF0000"/>
                </a:solidFill>
              </a:rPr>
              <a:t>S2, Slide </a:t>
            </a:r>
            <a:r>
              <a:rPr lang="en-US" sz="2800" b="1" dirty="0" smtClean="0">
                <a:solidFill>
                  <a:srgbClr val="FF0000"/>
                </a:solidFill>
              </a:rPr>
              <a:t>3: </a:t>
            </a:r>
            <a:r>
              <a:rPr lang="en-US" sz="2800" b="1" dirty="0">
                <a:solidFill>
                  <a:srgbClr val="FF0000"/>
                </a:solidFill>
              </a:rPr>
              <a:t>Fold </a:t>
            </a:r>
            <a:r>
              <a:rPr lang="en-US" sz="2800" b="1" dirty="0" smtClean="0">
                <a:solidFill>
                  <a:srgbClr val="FF0000"/>
                </a:solidFill>
              </a:rPr>
              <a:t>distribution in STEMI and NSTEMI</a:t>
            </a:r>
            <a:endParaRPr lang="en-US" sz="2800" b="1" dirty="0">
              <a:solidFill>
                <a:srgbClr val="FF0000"/>
              </a:solidFill>
            </a:endParaRPr>
          </a:p>
        </p:txBody>
      </p:sp>
      <p:pic>
        <p:nvPicPr>
          <p:cNvPr id="7" name="Content Placeholder 6"/>
          <p:cNvPicPr>
            <a:picLocks noGrp="1"/>
          </p:cNvPicPr>
          <p:nvPr>
            <p:ph sz="half"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748" r="24840" b="7035"/>
          <a:stretch/>
        </p:blipFill>
        <p:spPr bwMode="auto">
          <a:xfrm>
            <a:off x="838200" y="2374754"/>
            <a:ext cx="5181600" cy="3253079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560945" y="1825625"/>
            <a:ext cx="1169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TEMI</a:t>
            </a:r>
            <a:endParaRPr lang="en-US" dirty="0"/>
          </a:p>
        </p:txBody>
      </p:sp>
      <p:pic>
        <p:nvPicPr>
          <p:cNvPr id="9" name="Content Placeholder 8"/>
          <p:cNvPicPr>
            <a:picLocks noGrp="1"/>
          </p:cNvPicPr>
          <p:nvPr>
            <p:ph sz="half" idx="2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829" r="31136" b="7290"/>
          <a:stretch/>
        </p:blipFill>
        <p:spPr bwMode="auto">
          <a:xfrm>
            <a:off x="6172200" y="2173389"/>
            <a:ext cx="5181600" cy="3454444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7108305" y="1836002"/>
            <a:ext cx="1169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NSTEMI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409601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</TotalTime>
  <Words>48</Words>
  <Application>Microsoft Office PowerPoint</Application>
  <PresentationFormat>Widescreen</PresentationFormat>
  <Paragraphs>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B Nazanin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hammad Elahimanesh</dc:creator>
  <cp:lastModifiedBy>navid najafi</cp:lastModifiedBy>
  <cp:revision>13</cp:revision>
  <dcterms:created xsi:type="dcterms:W3CDTF">2023-07-01T16:01:23Z</dcterms:created>
  <dcterms:modified xsi:type="dcterms:W3CDTF">2024-01-31T16:10:16Z</dcterms:modified>
</cp:coreProperties>
</file>